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79B28-563E-4441-B3EF-1B0FB9C3593E}" type="datetimeFigureOut">
              <a:rPr lang="de-DE" smtClean="0"/>
              <a:t>16.1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E0726-2434-4C14-84A3-AA1DEC270AF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7956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79B28-563E-4441-B3EF-1B0FB9C3593E}" type="datetimeFigureOut">
              <a:rPr lang="de-DE" smtClean="0"/>
              <a:t>16.1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E0726-2434-4C14-84A3-AA1DEC270AF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64972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79B28-563E-4441-B3EF-1B0FB9C3593E}" type="datetimeFigureOut">
              <a:rPr lang="de-DE" smtClean="0"/>
              <a:t>16.1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E0726-2434-4C14-84A3-AA1DEC270AF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6360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79B28-563E-4441-B3EF-1B0FB9C3593E}" type="datetimeFigureOut">
              <a:rPr lang="de-DE" smtClean="0"/>
              <a:t>16.1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E0726-2434-4C14-84A3-AA1DEC270AF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884567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79B28-563E-4441-B3EF-1B0FB9C3593E}" type="datetimeFigureOut">
              <a:rPr lang="de-DE" smtClean="0"/>
              <a:t>16.1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E0726-2434-4C14-84A3-AA1DEC270AF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20983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79B28-563E-4441-B3EF-1B0FB9C3593E}" type="datetimeFigureOut">
              <a:rPr lang="de-DE" smtClean="0"/>
              <a:t>16.11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E0726-2434-4C14-84A3-AA1DEC270AF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09307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79B28-563E-4441-B3EF-1B0FB9C3593E}" type="datetimeFigureOut">
              <a:rPr lang="de-DE" smtClean="0"/>
              <a:t>16.11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E0726-2434-4C14-84A3-AA1DEC270AF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83976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79B28-563E-4441-B3EF-1B0FB9C3593E}" type="datetimeFigureOut">
              <a:rPr lang="de-DE" smtClean="0"/>
              <a:t>16.11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E0726-2434-4C14-84A3-AA1DEC270AF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422278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79B28-563E-4441-B3EF-1B0FB9C3593E}" type="datetimeFigureOut">
              <a:rPr lang="de-DE" smtClean="0"/>
              <a:t>16.11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E0726-2434-4C14-84A3-AA1DEC270AF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301757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79B28-563E-4441-B3EF-1B0FB9C3593E}" type="datetimeFigureOut">
              <a:rPr lang="de-DE" smtClean="0"/>
              <a:t>16.11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E0726-2434-4C14-84A3-AA1DEC270AF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39067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79B28-563E-4441-B3EF-1B0FB9C3593E}" type="datetimeFigureOut">
              <a:rPr lang="de-DE" smtClean="0"/>
              <a:t>16.11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E0726-2434-4C14-84A3-AA1DEC270AF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2354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579B28-563E-4441-B3EF-1B0FB9C3593E}" type="datetimeFigureOut">
              <a:rPr lang="de-DE" smtClean="0"/>
              <a:t>16.1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6E0726-2434-4C14-84A3-AA1DEC270AF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5354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1724025" y="1111079"/>
            <a:ext cx="6283153" cy="1821591"/>
            <a:chOff x="1724025" y="1111079"/>
            <a:chExt cx="6283153" cy="1821591"/>
          </a:xfrm>
        </p:grpSpPr>
        <p:pic>
          <p:nvPicPr>
            <p:cNvPr id="4" name="Grafik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24025" y="1111079"/>
              <a:ext cx="3086585" cy="1821591"/>
            </a:xfrm>
            <a:prstGeom prst="rect">
              <a:avLst/>
            </a:prstGeom>
          </p:spPr>
        </p:pic>
        <p:pic>
          <p:nvPicPr>
            <p:cNvPr id="5" name="Grafik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986210" y="1149803"/>
              <a:ext cx="3020968" cy="1782867"/>
            </a:xfrm>
            <a:prstGeom prst="rect">
              <a:avLst/>
            </a:prstGeom>
          </p:spPr>
        </p:pic>
      </p:grpSp>
      <p:sp>
        <p:nvSpPr>
          <p:cNvPr id="6" name="Textfeld 5"/>
          <p:cNvSpPr txBox="1"/>
          <p:nvPr/>
        </p:nvSpPr>
        <p:spPr>
          <a:xfrm>
            <a:off x="1087395" y="3286896"/>
            <a:ext cx="823783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 </a:t>
            </a:r>
            <a:r>
              <a:rPr lang="de-DE" dirty="0" smtClean="0"/>
              <a:t>2 </a:t>
            </a:r>
            <a:r>
              <a:rPr lang="en-GB" dirty="0"/>
              <a:t>Cox regression for  </a:t>
            </a:r>
            <a:r>
              <a:rPr lang="en-GB" dirty="0" err="1"/>
              <a:t>tTTP</a:t>
            </a:r>
            <a:r>
              <a:rPr lang="en-GB" dirty="0"/>
              <a:t>  and OS.  Definitive  includes lesions </a:t>
            </a:r>
            <a:r>
              <a:rPr lang="en-GB"/>
              <a:t>treated </a:t>
            </a:r>
            <a:r>
              <a:rPr lang="en-GB" smtClean="0"/>
              <a:t>with </a:t>
            </a:r>
            <a:r>
              <a:rPr lang="en-GB" dirty="0"/>
              <a:t>cRT</a:t>
            </a:r>
            <a:r>
              <a:rPr lang="en-GB" baseline="-25000" dirty="0"/>
              <a:t>50-60Gy</a:t>
            </a:r>
            <a:r>
              <a:rPr lang="en-GB" dirty="0"/>
              <a:t>, SBRT and BT; palliative includes lesions treated with cRT</a:t>
            </a:r>
            <a:r>
              <a:rPr lang="en-GB" baseline="-25000" dirty="0"/>
              <a:t>20-49 </a:t>
            </a:r>
            <a:r>
              <a:rPr lang="en-GB" baseline="-25000" dirty="0" err="1"/>
              <a:t>Gy</a:t>
            </a:r>
            <a:endParaRPr lang="de-DE" dirty="0"/>
          </a:p>
          <a:p>
            <a:endParaRPr lang="de-DE" dirty="0" smtClean="0"/>
          </a:p>
        </p:txBody>
      </p:sp>
    </p:spTree>
    <p:extLst>
      <p:ext uri="{BB962C8B-B14F-4D97-AF65-F5344CB8AC3E}">
        <p14:creationId xmlns:p14="http://schemas.microsoft.com/office/powerpoint/2010/main" val="4833403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KW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impel, Otilia</dc:creator>
  <cp:lastModifiedBy>Kimpel, Otilia</cp:lastModifiedBy>
  <cp:revision>2</cp:revision>
  <dcterms:created xsi:type="dcterms:W3CDTF">2022-10-09T11:49:53Z</dcterms:created>
  <dcterms:modified xsi:type="dcterms:W3CDTF">2022-11-16T11:40:04Z</dcterms:modified>
</cp:coreProperties>
</file>